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4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linerosj\Box%20Sync\HLA_paper\ForPaper\Phased\Accumulation_coun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Discovery-37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6850830910287159"/>
                  <c:y val="1.2888224162364226E-2"/>
                </c:manualLayout>
              </c:layout>
              <c:numFmt formatCode="General" sourceLinked="0"/>
              <c:spPr>
                <a:noFill/>
                <a:ln>
                  <a:solidFill>
                    <a:srgbClr val="0070C0"/>
                  </a:solidFill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cat>
            <c:strRef>
              <c:f>SummaryResultsRep!$BT$16:$BT$24</c:f>
              <c:strCach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+</c:v>
                </c:pt>
              </c:strCache>
            </c:strRef>
          </c:cat>
          <c:val>
            <c:numRef>
              <c:f>SummaryResultsRep!$BU$16:$BU$24</c:f>
              <c:numCache>
                <c:formatCode>0.00</c:formatCode>
                <c:ptCount val="9"/>
                <c:pt idx="0">
                  <c:v>1.0640651144323758</c:v>
                </c:pt>
                <c:pt idx="1">
                  <c:v>1.5371621621621618</c:v>
                </c:pt>
                <c:pt idx="2">
                  <c:v>1.9989801121876594</c:v>
                </c:pt>
                <c:pt idx="3">
                  <c:v>2.2708135270949348</c:v>
                </c:pt>
                <c:pt idx="4">
                  <c:v>2.854550663737943</c:v>
                </c:pt>
                <c:pt idx="5">
                  <c:v>3.8372270575660412</c:v>
                </c:pt>
                <c:pt idx="6">
                  <c:v>4.3031266560678318</c:v>
                </c:pt>
                <c:pt idx="7">
                  <c:v>5.7975263398992203</c:v>
                </c:pt>
              </c:numCache>
            </c:numRef>
          </c:val>
        </c:ser>
        <c:ser>
          <c:idx val="1"/>
          <c:order val="1"/>
          <c:tx>
            <c:v>Replication-37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trendline>
            <c:spPr>
              <a:ln w="19050" cap="rnd">
                <a:solidFill>
                  <a:schemeClr val="accent2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71378780482628357"/>
                  <c:y val="0.19406103675383263"/>
                </c:manualLayout>
              </c:layout>
              <c:numFmt formatCode="General" sourceLinked="0"/>
              <c:spPr>
                <a:noFill/>
                <a:ln>
                  <a:solidFill>
                    <a:schemeClr val="accent2"/>
                  </a:solidFill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cat>
            <c:strRef>
              <c:f>SummaryResultsRep!$BT$16:$BT$24</c:f>
              <c:strCach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+</c:v>
                </c:pt>
              </c:strCache>
            </c:strRef>
          </c:cat>
          <c:val>
            <c:numRef>
              <c:f>SummaryResultsRep!$BY$16:$BY$24</c:f>
              <c:numCache>
                <c:formatCode>0.00</c:formatCode>
                <c:ptCount val="9"/>
                <c:pt idx="0">
                  <c:v>1.2613315093479254</c:v>
                </c:pt>
                <c:pt idx="1">
                  <c:v>1.7380415292960847</c:v>
                </c:pt>
                <c:pt idx="2">
                  <c:v>2.4407748393475042</c:v>
                </c:pt>
                <c:pt idx="3">
                  <c:v>2.6187656270561912</c:v>
                </c:pt>
                <c:pt idx="4">
                  <c:v>2.7328618470288877</c:v>
                </c:pt>
                <c:pt idx="5">
                  <c:v>3.7306915132465202</c:v>
                </c:pt>
                <c:pt idx="6">
                  <c:v>5.5667973856209167</c:v>
                </c:pt>
                <c:pt idx="7">
                  <c:v>6.469040247678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1662760"/>
        <c:axId val="551661192"/>
      </c:barChart>
      <c:catAx>
        <c:axId val="5516627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Number</a:t>
                </a:r>
                <a:r>
                  <a:rPr lang="en-US" baseline="0" dirty="0" smtClean="0"/>
                  <a:t> of risk residues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661192"/>
        <c:crosses val="autoZero"/>
        <c:auto val="1"/>
        <c:lblAlgn val="ctr"/>
        <c:lblOffset val="100"/>
        <c:noMultiLvlLbl val="0"/>
      </c:catAx>
      <c:valAx>
        <c:axId val="5516611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Odds Ratio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6627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E2BF9-9E8C-474C-A75B-098ED579547A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2FC36-3B44-48F9-95D9-7F164D7CD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815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E2BF9-9E8C-474C-A75B-098ED579547A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2FC36-3B44-48F9-95D9-7F164D7CD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397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E2BF9-9E8C-474C-A75B-098ED579547A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2FC36-3B44-48F9-95D9-7F164D7CD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36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E2BF9-9E8C-474C-A75B-098ED579547A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2FC36-3B44-48F9-95D9-7F164D7CD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668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E2BF9-9E8C-474C-A75B-098ED579547A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2FC36-3B44-48F9-95D9-7F164D7CD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612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E2BF9-9E8C-474C-A75B-098ED579547A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2FC36-3B44-48F9-95D9-7F164D7CD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88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E2BF9-9E8C-474C-A75B-098ED579547A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2FC36-3B44-48F9-95D9-7F164D7CD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639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E2BF9-9E8C-474C-A75B-098ED579547A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2FC36-3B44-48F9-95D9-7F164D7CD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278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E2BF9-9E8C-474C-A75B-098ED579547A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2FC36-3B44-48F9-95D9-7F164D7CD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960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E2BF9-9E8C-474C-A75B-098ED579547A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2FC36-3B44-48F9-95D9-7F164D7CD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033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E2BF9-9E8C-474C-A75B-098ED579547A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2FC36-3B44-48F9-95D9-7F164D7CD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547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AE2BF9-9E8C-474C-A75B-098ED579547A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32FC36-3B44-48F9-95D9-7F164D7CD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304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42110" y="374072"/>
            <a:ext cx="1093734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Fig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ffect of the accumulation of risk amino acid residues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nd for the increasing risk with increasing number of risk alleles was observed in both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covery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replication cohorts. There was a linear relationship between increased ORs and number of risk residues (R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95; R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90 for discovery and replication respectively) suggests an additive effect.</a:t>
            </a: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/>
          </p:nvPr>
        </p:nvGraphicFramePr>
        <p:xfrm>
          <a:off x="2562225" y="1531143"/>
          <a:ext cx="7067550" cy="37957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561049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7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OMRF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o Molineros, PhD</dc:creator>
  <cp:lastModifiedBy>Julio Molineros, PhD</cp:lastModifiedBy>
  <cp:revision>1</cp:revision>
  <dcterms:created xsi:type="dcterms:W3CDTF">2019-02-20T18:45:57Z</dcterms:created>
  <dcterms:modified xsi:type="dcterms:W3CDTF">2019-02-20T18:50:42Z</dcterms:modified>
</cp:coreProperties>
</file>